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3" r:id="rId2"/>
    <p:sldId id="274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1"/>
    <p:restoredTop sz="94652"/>
  </p:normalViewPr>
  <p:slideViewPr>
    <p:cSldViewPr snapToGrid="0">
      <p:cViewPr varScale="1">
        <p:scale>
          <a:sx n="123" d="100"/>
          <a:sy n="123" d="100"/>
        </p:scale>
        <p:origin x="25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B21877-A875-4DD1-9A2F-4737B03B69DE}" type="datetimeFigureOut">
              <a:rPr lang="zh-CN" altLang="en-US" smtClean="0"/>
              <a:t>2025/7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C7D801-5C24-44CF-9D58-D3710F9D61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34281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08D0DC1-BBBB-CC0C-35B0-9A226EAB10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8C3360F-5049-0D95-E653-3D57ABAEEC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78B3CF8-117F-206B-0EDA-1DA28282F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83FA-BD2C-4C85-AA1B-6DD272936272}" type="datetimeFigureOut">
              <a:rPr lang="zh-CN" altLang="en-US" smtClean="0"/>
              <a:t>2025/7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BF40733-1F2F-5666-270C-7F6EBACA77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5D36E7-057D-C9D7-1573-D3FE5132DC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0A5C8-67AE-4221-876C-2166C76E18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646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FDE1E1A-C560-1D04-090B-D448ABBBE0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69FCC29-13D0-955F-A03A-C6539B6937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8AF9066-2B75-ACD1-2716-982CF0B73E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83FA-BD2C-4C85-AA1B-6DD272936272}" type="datetimeFigureOut">
              <a:rPr lang="zh-CN" altLang="en-US" smtClean="0"/>
              <a:t>2025/7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FEC65E1-94EA-96E4-825D-2B38AAAB98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987D017-7F33-7992-9C25-0C0D7E4755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0A5C8-67AE-4221-876C-2166C76E18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5553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0590060-3C20-263A-4D3F-F0DB41DD88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5486537-B924-7436-7D1A-DB8F0C3803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7C6957-D858-C8A2-DBCB-5926710F3E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83FA-BD2C-4C85-AA1B-6DD272936272}" type="datetimeFigureOut">
              <a:rPr lang="zh-CN" altLang="en-US" smtClean="0"/>
              <a:t>2025/7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DD4DF25-8116-9289-6E68-AC61950518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34293E1-BE1B-8E48-8EC4-8FCF662F6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0A5C8-67AE-4221-876C-2166C76E18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1157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5DA1AE-F053-5CDE-9B76-030C6F83B8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980E091-3415-3F00-C942-7192ADA08E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4DD97C4-56F8-FB33-8648-0E181567EA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83FA-BD2C-4C85-AA1B-6DD272936272}" type="datetimeFigureOut">
              <a:rPr lang="zh-CN" altLang="en-US" smtClean="0"/>
              <a:t>2025/7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0992D0A-8B1A-82BB-0FE4-64B55599B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9597E3-0DD8-6512-4388-E42799DDB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0A5C8-67AE-4221-876C-2166C76E18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6737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F85670-939B-2384-9845-6D3AB27DB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7292A90-CF17-1101-9459-A301AF9724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0D8B40A-7EB7-6781-404A-A0DFF13FA8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83FA-BD2C-4C85-AA1B-6DD272936272}" type="datetimeFigureOut">
              <a:rPr lang="zh-CN" altLang="en-US" smtClean="0"/>
              <a:t>2025/7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50A7462-E537-393E-C12C-77E0524958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007E83-00BA-9676-874C-BD897DF66F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0A5C8-67AE-4221-876C-2166C76E18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5309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CD3547-E06A-AEEC-8032-844BCCB8EB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E59CE83-0E3E-B290-E043-91450A98B9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0E5B03E-A8DB-2C7F-7557-08105FE1F4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F09C5D1-EC4F-E761-F684-2D8F00AD6B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83FA-BD2C-4C85-AA1B-6DD272936272}" type="datetimeFigureOut">
              <a:rPr lang="zh-CN" altLang="en-US" smtClean="0"/>
              <a:t>2025/7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C9D78A7-7B87-B223-0802-B1857FBE3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5D472C7-5282-40E9-82FD-B11846C783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0A5C8-67AE-4221-876C-2166C76E18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8125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A39741-4CA5-9F82-A211-069E7D7ADC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1305CA4-6C34-A743-8717-51FF56262F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9516BF2-3C06-CB19-3534-26DF430E39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9A75849-D617-F937-DA1B-19C951C085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12471F6-DC31-1929-60D1-21D8674F68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835392E-F516-F14D-719E-D1FBCBEF1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83FA-BD2C-4C85-AA1B-6DD272936272}" type="datetimeFigureOut">
              <a:rPr lang="zh-CN" altLang="en-US" smtClean="0"/>
              <a:t>2025/7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2179CF1-DD51-6B32-9FB0-E2C3D076D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2AD8405-F635-1E74-CBB8-59219DDB7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0A5C8-67AE-4221-876C-2166C76E18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7931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8A879B-F4D3-FBBA-42C3-44C0241E3F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162F701-F1FD-9068-FE0B-1A70C2EE9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83FA-BD2C-4C85-AA1B-6DD272936272}" type="datetimeFigureOut">
              <a:rPr lang="zh-CN" altLang="en-US" smtClean="0"/>
              <a:t>2025/7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3EA3BFD-13BB-FEFC-2D3C-06B1FC543A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D8C9ED6-DA25-9984-27F3-F1314E903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0A5C8-67AE-4221-876C-2166C76E18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9596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8B852E3-5EE2-B944-721B-1CB892C636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83FA-BD2C-4C85-AA1B-6DD272936272}" type="datetimeFigureOut">
              <a:rPr lang="zh-CN" altLang="en-US" smtClean="0"/>
              <a:t>2025/7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9505302-7650-E7AF-68B5-98D0A3122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91CF959-A544-0415-F8B4-0468B39839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0A5C8-67AE-4221-876C-2166C76E18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0730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D600F6-D94E-A254-5B8D-2C52307D07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344E9CC-0726-08DD-309E-5A659B9992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A60E782-78B3-9F0C-8AB9-E09330FC01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8C0739B-EAFE-C231-07D7-433E65EACF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83FA-BD2C-4C85-AA1B-6DD272936272}" type="datetimeFigureOut">
              <a:rPr lang="zh-CN" altLang="en-US" smtClean="0"/>
              <a:t>2025/7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53A64D8-45C4-EE46-6BCC-84F860373D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D51FB1C-3333-AF2A-5744-89022B04C4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0A5C8-67AE-4221-876C-2166C76E18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5346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32E264-0312-667D-AF2F-0758F66793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4477FD0-2917-E376-A0BE-42B3E3D4965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03032C5-7EC1-C65E-EB85-230E06EF8F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DE4BBF5-C5FF-4374-608F-6DEF426EEA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B83FA-BD2C-4C85-AA1B-6DD272936272}" type="datetimeFigureOut">
              <a:rPr lang="zh-CN" altLang="en-US" smtClean="0"/>
              <a:t>2025/7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3E4D6B8-0B11-CFE7-E290-0B260CAD9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2C262D5-B467-3BA5-A22F-9FA8726922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90A5C8-67AE-4221-876C-2166C76E18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4728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E140A31-A228-C93B-D272-8C89A78D35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07DA9DF-BF44-F560-9264-DE9590DF8C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D755327-E366-A278-CB47-C248638960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48B83FA-BD2C-4C85-AA1B-6DD272936272}" type="datetimeFigureOut">
              <a:rPr lang="zh-CN" altLang="en-US" smtClean="0"/>
              <a:t>2025/7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94BC76-A5AB-8836-B84E-1FF9E1E4BAF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D7E4FF-3E8F-2805-B998-B331540F2C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90A5C8-67AE-4221-876C-2166C76E18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7178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>
            <a:extLst>
              <a:ext uri="{FF2B5EF4-FFF2-40B4-BE49-F238E27FC236}">
                <a16:creationId xmlns:a16="http://schemas.microsoft.com/office/drawing/2014/main" id="{6FA81599-195B-8ED8-8B6F-BE7DCD6E1220}"/>
              </a:ext>
            </a:extLst>
          </p:cNvPr>
          <p:cNvGrpSpPr/>
          <p:nvPr/>
        </p:nvGrpSpPr>
        <p:grpSpPr>
          <a:xfrm>
            <a:off x="775931" y="82167"/>
            <a:ext cx="7956581" cy="5958708"/>
            <a:chOff x="775931" y="82167"/>
            <a:chExt cx="7956581" cy="5958708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E20CE893-F5AB-43DA-06F7-A38C57E977C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75931" y="82167"/>
              <a:ext cx="7918314" cy="2319440"/>
            </a:xfrm>
            <a:prstGeom prst="rect">
              <a:avLst/>
            </a:prstGeom>
          </p:spPr>
        </p:pic>
        <p:grpSp>
          <p:nvGrpSpPr>
            <p:cNvPr id="16" name="组合 15">
              <a:extLst>
                <a:ext uri="{FF2B5EF4-FFF2-40B4-BE49-F238E27FC236}">
                  <a16:creationId xmlns:a16="http://schemas.microsoft.com/office/drawing/2014/main" id="{B793BDCD-53DA-1520-3A07-8A527B9FD9B5}"/>
                </a:ext>
              </a:extLst>
            </p:cNvPr>
            <p:cNvGrpSpPr/>
            <p:nvPr/>
          </p:nvGrpSpPr>
          <p:grpSpPr>
            <a:xfrm>
              <a:off x="1129907" y="2368055"/>
              <a:ext cx="7602605" cy="3672820"/>
              <a:chOff x="1129907" y="2368055"/>
              <a:chExt cx="7602605" cy="3672820"/>
            </a:xfrm>
          </p:grpSpPr>
          <p:grpSp>
            <p:nvGrpSpPr>
              <p:cNvPr id="13" name="组合 12">
                <a:extLst>
                  <a:ext uri="{FF2B5EF4-FFF2-40B4-BE49-F238E27FC236}">
                    <a16:creationId xmlns:a16="http://schemas.microsoft.com/office/drawing/2014/main" id="{81E9A13C-49C5-F0A4-85AF-0338B6EACFF0}"/>
                  </a:ext>
                </a:extLst>
              </p:cNvPr>
              <p:cNvGrpSpPr/>
              <p:nvPr/>
            </p:nvGrpSpPr>
            <p:grpSpPr>
              <a:xfrm>
                <a:off x="2916896" y="4292892"/>
                <a:ext cx="5777349" cy="1709069"/>
                <a:chOff x="2220886" y="4662548"/>
                <a:chExt cx="5777349" cy="1709069"/>
              </a:xfrm>
            </p:grpSpPr>
            <p:pic>
              <p:nvPicPr>
                <p:cNvPr id="7" name="图片 6">
                  <a:extLst>
                    <a:ext uri="{FF2B5EF4-FFF2-40B4-BE49-F238E27FC236}">
                      <a16:creationId xmlns:a16="http://schemas.microsoft.com/office/drawing/2014/main" id="{00CCF6DF-5B37-0029-46DF-C463DEA304C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rcRect t="2062" b="17440"/>
                <a:stretch>
                  <a:fillRect/>
                </a:stretch>
              </p:blipFill>
              <p:spPr>
                <a:xfrm>
                  <a:off x="2220886" y="4662548"/>
                  <a:ext cx="5632538" cy="1709069"/>
                </a:xfrm>
                <a:prstGeom prst="rect">
                  <a:avLst/>
                </a:prstGeom>
              </p:spPr>
            </p:pic>
            <p:sp>
              <p:nvSpPr>
                <p:cNvPr id="4" name="文本框 3">
                  <a:extLst>
                    <a:ext uri="{FF2B5EF4-FFF2-40B4-BE49-F238E27FC236}">
                      <a16:creationId xmlns:a16="http://schemas.microsoft.com/office/drawing/2014/main" id="{7B8B4D47-9C31-3C5B-77A7-9C742FAA9E57}"/>
                    </a:ext>
                  </a:extLst>
                </p:cNvPr>
                <p:cNvSpPr txBox="1"/>
                <p:nvPr/>
              </p:nvSpPr>
              <p:spPr>
                <a:xfrm>
                  <a:off x="6439067" y="4719857"/>
                  <a:ext cx="155916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MC+H446+M18/IL15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文本框 8">
                  <a:extLst>
                    <a:ext uri="{FF2B5EF4-FFF2-40B4-BE49-F238E27FC236}">
                      <a16:creationId xmlns:a16="http://schemas.microsoft.com/office/drawing/2014/main" id="{08F3CDFC-1683-7D9F-9E2E-A1371AF44D6C}"/>
                    </a:ext>
                  </a:extLst>
                </p:cNvPr>
                <p:cNvSpPr txBox="1"/>
                <p:nvPr/>
              </p:nvSpPr>
              <p:spPr>
                <a:xfrm>
                  <a:off x="2935967" y="4719857"/>
                  <a:ext cx="155916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MC+M4-OKT3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文本框 9">
                  <a:extLst>
                    <a:ext uri="{FF2B5EF4-FFF2-40B4-BE49-F238E27FC236}">
                      <a16:creationId xmlns:a16="http://schemas.microsoft.com/office/drawing/2014/main" id="{29495817-EC68-299C-55CD-95545156D693}"/>
                    </a:ext>
                  </a:extLst>
                </p:cNvPr>
                <p:cNvSpPr txBox="1"/>
                <p:nvPr/>
              </p:nvSpPr>
              <p:spPr>
                <a:xfrm>
                  <a:off x="4735088" y="4719857"/>
                  <a:ext cx="155916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MC+M4-LC21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" name="组合 11">
                <a:extLst>
                  <a:ext uri="{FF2B5EF4-FFF2-40B4-BE49-F238E27FC236}">
                    <a16:creationId xmlns:a16="http://schemas.microsoft.com/office/drawing/2014/main" id="{6EF52C4A-96A4-11DD-2626-3CC5FEE8C6B1}"/>
                  </a:ext>
                </a:extLst>
              </p:cNvPr>
              <p:cNvGrpSpPr/>
              <p:nvPr/>
            </p:nvGrpSpPr>
            <p:grpSpPr>
              <a:xfrm>
                <a:off x="1129907" y="2457794"/>
                <a:ext cx="7602605" cy="1803103"/>
                <a:chOff x="424814" y="2527449"/>
                <a:chExt cx="7602605" cy="1803103"/>
              </a:xfrm>
            </p:grpSpPr>
            <p:pic>
              <p:nvPicPr>
                <p:cNvPr id="5" name="图片 4">
                  <a:extLst>
                    <a:ext uri="{FF2B5EF4-FFF2-40B4-BE49-F238E27FC236}">
                      <a16:creationId xmlns:a16="http://schemas.microsoft.com/office/drawing/2014/main" id="{6BFFE844-7E5F-8720-AAED-4379B087E0D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rcRect b="15549"/>
                <a:stretch>
                  <a:fillRect/>
                </a:stretch>
              </p:blipFill>
              <p:spPr>
                <a:xfrm>
                  <a:off x="424814" y="2527449"/>
                  <a:ext cx="7418882" cy="1803103"/>
                </a:xfrm>
                <a:prstGeom prst="rect">
                  <a:avLst/>
                </a:prstGeom>
              </p:spPr>
            </p:pic>
            <p:sp>
              <p:nvSpPr>
                <p:cNvPr id="2" name="文本框 1">
                  <a:extLst>
                    <a:ext uri="{FF2B5EF4-FFF2-40B4-BE49-F238E27FC236}">
                      <a16:creationId xmlns:a16="http://schemas.microsoft.com/office/drawing/2014/main" id="{2D9F929F-491D-FBD5-6A89-FC14580E1FF6}"/>
                    </a:ext>
                  </a:extLst>
                </p:cNvPr>
                <p:cNvSpPr txBox="1"/>
                <p:nvPr/>
              </p:nvSpPr>
              <p:spPr>
                <a:xfrm>
                  <a:off x="6468251" y="2606517"/>
                  <a:ext cx="155916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MC+H446+M18/IL15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" name="文本框 5">
                  <a:extLst>
                    <a:ext uri="{FF2B5EF4-FFF2-40B4-BE49-F238E27FC236}">
                      <a16:creationId xmlns:a16="http://schemas.microsoft.com/office/drawing/2014/main" id="{2A1883DB-C24D-3DF9-3373-552BE76DB216}"/>
                    </a:ext>
                  </a:extLst>
                </p:cNvPr>
                <p:cNvSpPr txBox="1"/>
                <p:nvPr/>
              </p:nvSpPr>
              <p:spPr>
                <a:xfrm>
                  <a:off x="4616753" y="2609157"/>
                  <a:ext cx="155916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MC+H446+M4-LC21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文本框 7">
                  <a:extLst>
                    <a:ext uri="{FF2B5EF4-FFF2-40B4-BE49-F238E27FC236}">
                      <a16:creationId xmlns:a16="http://schemas.microsoft.com/office/drawing/2014/main" id="{8C769A1F-A587-737D-9C4B-813ADE440BF7}"/>
                    </a:ext>
                  </a:extLst>
                </p:cNvPr>
                <p:cNvSpPr txBox="1"/>
                <p:nvPr/>
              </p:nvSpPr>
              <p:spPr>
                <a:xfrm>
                  <a:off x="2793295" y="2592416"/>
                  <a:ext cx="155916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MC+H446+M4-OKT3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文本框 10">
                  <a:extLst>
                    <a:ext uri="{FF2B5EF4-FFF2-40B4-BE49-F238E27FC236}">
                      <a16:creationId xmlns:a16="http://schemas.microsoft.com/office/drawing/2014/main" id="{FEFC11A7-F671-EDA8-D29E-348A6360F316}"/>
                    </a:ext>
                  </a:extLst>
                </p:cNvPr>
                <p:cNvSpPr txBox="1"/>
                <p:nvPr/>
              </p:nvSpPr>
              <p:spPr>
                <a:xfrm>
                  <a:off x="1234127" y="2609157"/>
                  <a:ext cx="1559168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MC+H446</a:t>
                  </a:r>
                  <a:endParaRPr lang="zh-CN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4" name="矩形: 圆角 13">
                <a:extLst>
                  <a:ext uri="{FF2B5EF4-FFF2-40B4-BE49-F238E27FC236}">
                    <a16:creationId xmlns:a16="http://schemas.microsoft.com/office/drawing/2014/main" id="{E21B543E-2FF4-5221-6E70-41326C070603}"/>
                  </a:ext>
                </a:extLst>
              </p:cNvPr>
              <p:cNvSpPr/>
              <p:nvPr/>
            </p:nvSpPr>
            <p:spPr>
              <a:xfrm>
                <a:off x="3035030" y="2382151"/>
                <a:ext cx="1857983" cy="3658724"/>
              </a:xfrm>
              <a:prstGeom prst="roundRect">
                <a:avLst/>
              </a:prstGeom>
              <a:noFill/>
              <a:ln w="9525">
                <a:solidFill>
                  <a:schemeClr val="tx1"/>
                </a:solidFill>
                <a:prstDash val="lg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5" name="矩形: 圆角 14">
                <a:extLst>
                  <a:ext uri="{FF2B5EF4-FFF2-40B4-BE49-F238E27FC236}">
                    <a16:creationId xmlns:a16="http://schemas.microsoft.com/office/drawing/2014/main" id="{93FBA173-0B25-4028-70C9-F467DE0DA2C0}"/>
                  </a:ext>
                </a:extLst>
              </p:cNvPr>
              <p:cNvSpPr/>
              <p:nvPr/>
            </p:nvSpPr>
            <p:spPr>
              <a:xfrm>
                <a:off x="6700534" y="2368055"/>
                <a:ext cx="1857983" cy="3658724"/>
              </a:xfrm>
              <a:prstGeom prst="roundRect">
                <a:avLst/>
              </a:prstGeom>
              <a:noFill/>
              <a:ln w="9525">
                <a:solidFill>
                  <a:schemeClr val="tx1"/>
                </a:solidFill>
                <a:prstDash val="lg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  <p:sp>
        <p:nvSpPr>
          <p:cNvPr id="18" name="文本框 17">
            <a:extLst>
              <a:ext uri="{FF2B5EF4-FFF2-40B4-BE49-F238E27FC236}">
                <a16:creationId xmlns:a16="http://schemas.microsoft.com/office/drawing/2014/main" id="{C1E5A0DA-E325-E24D-D8A0-5852C14064EA}"/>
              </a:ext>
            </a:extLst>
          </p:cNvPr>
          <p:cNvSpPr txBox="1"/>
          <p:nvPr/>
        </p:nvSpPr>
        <p:spPr>
          <a:xfrm>
            <a:off x="599267" y="82167"/>
            <a:ext cx="662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0BEB843-12EF-3493-17A4-B55262EC0004}"/>
              </a:ext>
            </a:extLst>
          </p:cNvPr>
          <p:cNvSpPr txBox="1"/>
          <p:nvPr/>
        </p:nvSpPr>
        <p:spPr>
          <a:xfrm>
            <a:off x="653226" y="2351512"/>
            <a:ext cx="662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2C03E39-EA38-8F75-ED47-56E3DC2C683A}"/>
              </a:ext>
            </a:extLst>
          </p:cNvPr>
          <p:cNvSpPr txBox="1"/>
          <p:nvPr/>
        </p:nvSpPr>
        <p:spPr>
          <a:xfrm>
            <a:off x="9338552" y="2110902"/>
            <a:ext cx="2480553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. T-cell gating strategy</a:t>
            </a:r>
          </a:p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zh-CN" alt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69 expression after 24-hour treatments.CD69 expression on T cells (gated as CD3⁺ lymphocytes) .The dashed box panels are reproduced from Fig. 6B and 6E for cross-group comparison convenience.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D4B30E20-A3FF-1917-E9C9-759BA0090774}"/>
              </a:ext>
            </a:extLst>
          </p:cNvPr>
          <p:cNvSpPr txBox="1"/>
          <p:nvPr/>
        </p:nvSpPr>
        <p:spPr>
          <a:xfrm>
            <a:off x="11191405" y="-13103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12274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组合 21">
            <a:extLst>
              <a:ext uri="{FF2B5EF4-FFF2-40B4-BE49-F238E27FC236}">
                <a16:creationId xmlns:a16="http://schemas.microsoft.com/office/drawing/2014/main" id="{8160F316-2FDC-C297-7739-60265D2418F3}"/>
              </a:ext>
            </a:extLst>
          </p:cNvPr>
          <p:cNvGrpSpPr/>
          <p:nvPr/>
        </p:nvGrpSpPr>
        <p:grpSpPr>
          <a:xfrm>
            <a:off x="884540" y="411899"/>
            <a:ext cx="7687616" cy="5703556"/>
            <a:chOff x="884540" y="411899"/>
            <a:chExt cx="7687616" cy="5703556"/>
          </a:xfrm>
        </p:grpSpPr>
        <p:grpSp>
          <p:nvGrpSpPr>
            <p:cNvPr id="19" name="组合 18">
              <a:extLst>
                <a:ext uri="{FF2B5EF4-FFF2-40B4-BE49-F238E27FC236}">
                  <a16:creationId xmlns:a16="http://schemas.microsoft.com/office/drawing/2014/main" id="{6E8E7822-68CF-061C-A644-FB4CAD78827B}"/>
                </a:ext>
              </a:extLst>
            </p:cNvPr>
            <p:cNvGrpSpPr/>
            <p:nvPr/>
          </p:nvGrpSpPr>
          <p:grpSpPr>
            <a:xfrm>
              <a:off x="884540" y="411899"/>
              <a:ext cx="7687616" cy="5628988"/>
              <a:chOff x="96599" y="411899"/>
              <a:chExt cx="7687616" cy="5628988"/>
            </a:xfrm>
          </p:grpSpPr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71A2BA94-726E-FD48-ACF2-D17874BCB8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96599" y="411899"/>
                <a:ext cx="7478676" cy="2044715"/>
              </a:xfrm>
              <a:prstGeom prst="rect">
                <a:avLst/>
              </a:prstGeom>
            </p:spPr>
          </p:pic>
          <p:grpSp>
            <p:nvGrpSpPr>
              <p:cNvPr id="18" name="组合 17">
                <a:extLst>
                  <a:ext uri="{FF2B5EF4-FFF2-40B4-BE49-F238E27FC236}">
                    <a16:creationId xmlns:a16="http://schemas.microsoft.com/office/drawing/2014/main" id="{A4A895CD-583F-2388-0AA2-ECF111DAB66F}"/>
                  </a:ext>
                </a:extLst>
              </p:cNvPr>
              <p:cNvGrpSpPr/>
              <p:nvPr/>
            </p:nvGrpSpPr>
            <p:grpSpPr>
              <a:xfrm>
                <a:off x="425157" y="2547755"/>
                <a:ext cx="7359058" cy="3493132"/>
                <a:chOff x="298697" y="2547755"/>
                <a:chExt cx="7359058" cy="3493132"/>
              </a:xfrm>
            </p:grpSpPr>
            <p:grpSp>
              <p:nvGrpSpPr>
                <p:cNvPr id="14" name="组合 13">
                  <a:extLst>
                    <a:ext uri="{FF2B5EF4-FFF2-40B4-BE49-F238E27FC236}">
                      <a16:creationId xmlns:a16="http://schemas.microsoft.com/office/drawing/2014/main" id="{0BC452D6-BF20-159A-A973-9E2B84960DC6}"/>
                    </a:ext>
                  </a:extLst>
                </p:cNvPr>
                <p:cNvGrpSpPr/>
                <p:nvPr/>
              </p:nvGrpSpPr>
              <p:grpSpPr>
                <a:xfrm>
                  <a:off x="2127804" y="4330887"/>
                  <a:ext cx="5510495" cy="1710000"/>
                  <a:chOff x="2088892" y="4379527"/>
                  <a:chExt cx="5510495" cy="1710000"/>
                </a:xfrm>
              </p:grpSpPr>
              <p:pic>
                <p:nvPicPr>
                  <p:cNvPr id="6" name="图片 5">
                    <a:extLst>
                      <a:ext uri="{FF2B5EF4-FFF2-40B4-BE49-F238E27FC236}">
                        <a16:creationId xmlns:a16="http://schemas.microsoft.com/office/drawing/2014/main" id="{98825FF5-083F-43F8-348E-B67A71CEA43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2088892" y="4379527"/>
                    <a:ext cx="5321011" cy="1710000"/>
                  </a:xfrm>
                  <a:prstGeom prst="rect">
                    <a:avLst/>
                  </a:prstGeom>
                </p:spPr>
              </p:pic>
              <p:sp>
                <p:nvSpPr>
                  <p:cNvPr id="8" name="文本框 7">
                    <a:extLst>
                      <a:ext uri="{FF2B5EF4-FFF2-40B4-BE49-F238E27FC236}">
                        <a16:creationId xmlns:a16="http://schemas.microsoft.com/office/drawing/2014/main" id="{5C39697B-6E0A-6E36-2A44-2CE2F84CF4F7}"/>
                      </a:ext>
                    </a:extLst>
                  </p:cNvPr>
                  <p:cNvSpPr txBox="1"/>
                  <p:nvPr/>
                </p:nvSpPr>
                <p:spPr>
                  <a:xfrm>
                    <a:off x="6040219" y="4428030"/>
                    <a:ext cx="155916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BMC+H446+M18/IL15</a:t>
                    </a:r>
                    <a:endParaRPr lang="zh-CN" alt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" name="文本框 10">
                    <a:extLst>
                      <a:ext uri="{FF2B5EF4-FFF2-40B4-BE49-F238E27FC236}">
                        <a16:creationId xmlns:a16="http://schemas.microsoft.com/office/drawing/2014/main" id="{7F80F92A-9894-EF32-9134-2AB45764559C}"/>
                      </a:ext>
                    </a:extLst>
                  </p:cNvPr>
                  <p:cNvSpPr txBox="1"/>
                  <p:nvPr/>
                </p:nvSpPr>
                <p:spPr>
                  <a:xfrm>
                    <a:off x="2537119" y="4428030"/>
                    <a:ext cx="155916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BMC+M4-OKT3</a:t>
                    </a:r>
                    <a:endParaRPr lang="zh-CN" alt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" name="文本框 11">
                    <a:extLst>
                      <a:ext uri="{FF2B5EF4-FFF2-40B4-BE49-F238E27FC236}">
                        <a16:creationId xmlns:a16="http://schemas.microsoft.com/office/drawing/2014/main" id="{573327BD-DBA7-5742-DF3B-BC9CFAC9AE2F}"/>
                      </a:ext>
                    </a:extLst>
                  </p:cNvPr>
                  <p:cNvSpPr txBox="1"/>
                  <p:nvPr/>
                </p:nvSpPr>
                <p:spPr>
                  <a:xfrm>
                    <a:off x="4336240" y="4428030"/>
                    <a:ext cx="155916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BMC+M4-LC21</a:t>
                    </a:r>
                    <a:endParaRPr lang="zh-CN" alt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7" name="组合 16">
                  <a:extLst>
                    <a:ext uri="{FF2B5EF4-FFF2-40B4-BE49-F238E27FC236}">
                      <a16:creationId xmlns:a16="http://schemas.microsoft.com/office/drawing/2014/main" id="{125DC8BE-8D29-8A99-40A9-E9E09273615D}"/>
                    </a:ext>
                  </a:extLst>
                </p:cNvPr>
                <p:cNvGrpSpPr/>
                <p:nvPr/>
              </p:nvGrpSpPr>
              <p:grpSpPr>
                <a:xfrm>
                  <a:off x="298697" y="2547755"/>
                  <a:ext cx="7359058" cy="1710000"/>
                  <a:chOff x="298697" y="2547755"/>
                  <a:chExt cx="7359058" cy="1710000"/>
                </a:xfrm>
              </p:grpSpPr>
              <p:pic>
                <p:nvPicPr>
                  <p:cNvPr id="4" name="图片 3">
                    <a:extLst>
                      <a:ext uri="{FF2B5EF4-FFF2-40B4-BE49-F238E27FC236}">
                        <a16:creationId xmlns:a16="http://schemas.microsoft.com/office/drawing/2014/main" id="{B5419EEA-3658-F8A1-3146-C8078D1C939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298697" y="2547755"/>
                    <a:ext cx="7111206" cy="1710000"/>
                  </a:xfrm>
                  <a:prstGeom prst="rect">
                    <a:avLst/>
                  </a:prstGeom>
                </p:spPr>
              </p:pic>
              <p:sp>
                <p:nvSpPr>
                  <p:cNvPr id="7" name="文本框 6">
                    <a:extLst>
                      <a:ext uri="{FF2B5EF4-FFF2-40B4-BE49-F238E27FC236}">
                        <a16:creationId xmlns:a16="http://schemas.microsoft.com/office/drawing/2014/main" id="{BC95DE76-04E7-861F-F1D5-E1D55A59ED06}"/>
                      </a:ext>
                    </a:extLst>
                  </p:cNvPr>
                  <p:cNvSpPr txBox="1"/>
                  <p:nvPr/>
                </p:nvSpPr>
                <p:spPr>
                  <a:xfrm>
                    <a:off x="6098587" y="2587061"/>
                    <a:ext cx="155916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BMC+H446+M18/IL15</a:t>
                    </a:r>
                    <a:endParaRPr lang="zh-CN" alt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" name="文本框 8">
                    <a:extLst>
                      <a:ext uri="{FF2B5EF4-FFF2-40B4-BE49-F238E27FC236}">
                        <a16:creationId xmlns:a16="http://schemas.microsoft.com/office/drawing/2014/main" id="{02F47F2E-8B52-1121-F43D-9C19B517CCBE}"/>
                      </a:ext>
                    </a:extLst>
                  </p:cNvPr>
                  <p:cNvSpPr txBox="1"/>
                  <p:nvPr/>
                </p:nvSpPr>
                <p:spPr>
                  <a:xfrm>
                    <a:off x="4247089" y="2589701"/>
                    <a:ext cx="155916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BMC+H446+M4-LC21</a:t>
                    </a:r>
                    <a:endParaRPr lang="zh-CN" alt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" name="文本框 9">
                    <a:extLst>
                      <a:ext uri="{FF2B5EF4-FFF2-40B4-BE49-F238E27FC236}">
                        <a16:creationId xmlns:a16="http://schemas.microsoft.com/office/drawing/2014/main" id="{EEFCD9AE-379D-981C-022D-CA995B8BAE3E}"/>
                      </a:ext>
                    </a:extLst>
                  </p:cNvPr>
                  <p:cNvSpPr txBox="1"/>
                  <p:nvPr/>
                </p:nvSpPr>
                <p:spPr>
                  <a:xfrm>
                    <a:off x="2423631" y="2572960"/>
                    <a:ext cx="155916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BMC+H446+M4-OKT3</a:t>
                    </a:r>
                    <a:endParaRPr lang="zh-CN" alt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" name="文本框 12">
                    <a:extLst>
                      <a:ext uri="{FF2B5EF4-FFF2-40B4-BE49-F238E27FC236}">
                        <a16:creationId xmlns:a16="http://schemas.microsoft.com/office/drawing/2014/main" id="{D19618E5-4426-1C2E-CC16-C6997D5F0A2C}"/>
                      </a:ext>
                    </a:extLst>
                  </p:cNvPr>
                  <p:cNvSpPr txBox="1"/>
                  <p:nvPr/>
                </p:nvSpPr>
                <p:spPr>
                  <a:xfrm>
                    <a:off x="864463" y="2589701"/>
                    <a:ext cx="155916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BMC+H446</a:t>
                    </a:r>
                    <a:endParaRPr lang="zh-CN" alt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20" name="矩形: 圆角 19">
              <a:extLst>
                <a:ext uri="{FF2B5EF4-FFF2-40B4-BE49-F238E27FC236}">
                  <a16:creationId xmlns:a16="http://schemas.microsoft.com/office/drawing/2014/main" id="{6B7F0D19-90C3-4E55-A142-9DF4EFFEE6E8}"/>
                </a:ext>
              </a:extLst>
            </p:cNvPr>
            <p:cNvSpPr/>
            <p:nvPr/>
          </p:nvSpPr>
          <p:spPr>
            <a:xfrm>
              <a:off x="4806488" y="2453370"/>
              <a:ext cx="1792443" cy="3662085"/>
            </a:xfrm>
            <a:prstGeom prst="roundRect">
              <a:avLst/>
            </a:prstGeom>
            <a:noFill/>
            <a:ln w="9525">
              <a:solidFill>
                <a:schemeClr val="tx1"/>
              </a:solidFill>
              <a:prstDash val="lg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" name="矩形: 圆角 20">
              <a:extLst>
                <a:ext uri="{FF2B5EF4-FFF2-40B4-BE49-F238E27FC236}">
                  <a16:creationId xmlns:a16="http://schemas.microsoft.com/office/drawing/2014/main" id="{5B7FE1C7-CEA0-BB5C-BC03-64B3AD1DED02}"/>
                </a:ext>
              </a:extLst>
            </p:cNvPr>
            <p:cNvSpPr/>
            <p:nvPr/>
          </p:nvSpPr>
          <p:spPr>
            <a:xfrm>
              <a:off x="6589561" y="2453370"/>
              <a:ext cx="1792443" cy="3662085"/>
            </a:xfrm>
            <a:prstGeom prst="roundRect">
              <a:avLst/>
            </a:prstGeom>
            <a:noFill/>
            <a:ln w="9525">
              <a:solidFill>
                <a:schemeClr val="tx1"/>
              </a:solidFill>
              <a:prstDash val="lg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3" name="文本框 22">
            <a:extLst>
              <a:ext uri="{FF2B5EF4-FFF2-40B4-BE49-F238E27FC236}">
                <a16:creationId xmlns:a16="http://schemas.microsoft.com/office/drawing/2014/main" id="{54687F6F-832E-4583-2B90-DA671AAAD111}"/>
              </a:ext>
            </a:extLst>
          </p:cNvPr>
          <p:cNvSpPr txBox="1"/>
          <p:nvPr/>
        </p:nvSpPr>
        <p:spPr>
          <a:xfrm>
            <a:off x="553375" y="320758"/>
            <a:ext cx="662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D41EE46-8597-B292-FCCD-98944F7187C2}"/>
              </a:ext>
            </a:extLst>
          </p:cNvPr>
          <p:cNvSpPr txBox="1"/>
          <p:nvPr/>
        </p:nvSpPr>
        <p:spPr>
          <a:xfrm>
            <a:off x="653226" y="2351512"/>
            <a:ext cx="6623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34BF2E59-C163-25A2-99D8-C13183635EC1}"/>
              </a:ext>
            </a:extLst>
          </p:cNvPr>
          <p:cNvSpPr txBox="1"/>
          <p:nvPr/>
        </p:nvSpPr>
        <p:spPr>
          <a:xfrm>
            <a:off x="9251270" y="1909483"/>
            <a:ext cx="2323732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. </a:t>
            </a:r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K</a:t>
            </a: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cell gating strategy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.</a:t>
            </a:r>
            <a:r>
              <a:rPr kumimoji="0" lang="zh-CN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D69 expression after 24-hour treatments.CD69 expression on NK cells (gated as CD16⁺ lymphocytes) .The dashed box panels are reproduced from Fig. 6C and 6D for cross-group comparison convenience.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E1E85E71-4DE7-A15C-E3B4-4F625499B45C}"/>
              </a:ext>
            </a:extLst>
          </p:cNvPr>
          <p:cNvSpPr txBox="1"/>
          <p:nvPr/>
        </p:nvSpPr>
        <p:spPr>
          <a:xfrm>
            <a:off x="11191405" y="-13103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7221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8</TotalTime>
  <Words>160</Words>
  <Application>Microsoft Macintosh PowerPoint</Application>
  <PresentationFormat>宽屏</PresentationFormat>
  <Paragraphs>2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0</dc:creator>
  <cp:lastModifiedBy>Microsoft Office User</cp:lastModifiedBy>
  <cp:revision>35</cp:revision>
  <dcterms:created xsi:type="dcterms:W3CDTF">2025-07-12T03:35:06Z</dcterms:created>
  <dcterms:modified xsi:type="dcterms:W3CDTF">2025-07-14T00:31:53Z</dcterms:modified>
</cp:coreProperties>
</file>